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9ADA7"/>
    <a:srgbClr val="4A4E69"/>
    <a:srgbClr val="F2E9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20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5000E6-9E7F-ADE7-C1F8-B4032ABEF7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82DF40-BEB5-3A89-B0C4-533C96E5DD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989281-4824-640D-4AF4-DC1E846AB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1E5BA-2262-44AA-9A7E-4D5D0D7DF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1B76F0-9910-4598-9797-7F0F3EF1A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75810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C4400-1C0A-653A-3616-B44F4C0AF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B5C649-F91E-19EE-BB01-9D6D669BB9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ABDB3C-9599-18A4-9234-0FAF40D84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95FBC-4724-2112-9F0E-8962AE4C0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EDD42B-03E7-161A-901E-39FD96F98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5928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12BE76-3E8B-120F-E594-7389321028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CB1D2E-5B87-F3C4-D1E9-30171686E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A5FBE2-7092-BF1E-2AE7-7D2E9427D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77781B-404A-4E51-40BC-C98394EF3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1D6DB9-571E-7BD0-0421-D846A9848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54064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D8AB1-82EC-4A9E-32EF-F979598253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A83044-3BE9-F2F2-667A-5AFBFAC6F2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42BDCF-6CB2-45AC-8A3A-BA4E48BDC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46DAAD-B324-1D10-54EC-965C6BEB2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22B24E-1DED-F175-91E0-FD2E0FF5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47730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8A480-8CDB-D6B5-0A62-61A3C530C0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A61BB2-E7E9-6F7F-B549-70F7A204DE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95C03C-2543-3653-2B2D-FC9C9720F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3B245C-0B0B-7213-5A10-C15749762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4761CA-95B7-9F8B-E82E-064BD13A1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61385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1348C-18BC-7ACA-FDD1-DB3A99587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00CAFC-1671-A38F-86E7-B69B835127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86A577-6733-AEC1-15B2-C457C214B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1F6451-4509-C3B1-9577-B8626109F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888243-5189-EC3D-5BA6-CB1F1AB87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E9E053-0EE5-00D9-3640-21064C615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12215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FCE87E-A530-7D44-949F-35EDD37DF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18B680-48EB-896B-15FF-F8FDD7A340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56D12E-6734-070B-7EA2-373183A755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B32D46C-32B2-1B2D-FDF7-B2734338DC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6B3829-B695-A547-A5C5-9D444D4112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282ABE-317D-A4EC-47DE-5928B3D04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80EDF5-7342-0EB6-3B1E-6B9B6A10D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B87310-8C5B-AEA5-4976-B0718119B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90921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2A458A-2E2B-96A2-8AB4-FBD9FD997B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F2B4CF-24DE-D158-6FB6-26D9725CCC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99122F-2739-3382-3FCA-0E469E288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0D9E85-1641-EC52-3B73-BCB3887E4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72112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8AA72C-5FA3-8198-2792-A50E10A68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C87BA9B-DEA6-8E48-8426-77AEFB29D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DD35B9-6DCA-E376-BB0A-A25DEAFCF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502850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6F17B-188D-F250-87BD-9A007DA9AB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183BB6-2350-1F97-79AC-D3A17F6F19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8D078E-424A-49E8-69D6-2814862871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CCC5DB-514C-4821-7FFD-4B9C07A76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B9AAC8-EB11-E8AC-C468-C3C295FA61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2EAC53-587C-D3A7-FB7A-A7BFC9512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0040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E0D1C-2711-6E28-F8C6-C9DE13EB7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0CB85D-35E4-FA5B-312A-DC020767E0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21CAEC-18AE-81F5-1D7A-F5538C10BB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6D994F-01B5-E6CE-D569-048E0C759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6AB670-1C83-94E4-DAD7-D73B7EDF9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DA642E-42C5-D282-E3BE-DE2DE46FE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48563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65E6A0-88ED-829A-E5E5-F68FC5825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033C5E-24F9-A5C4-7904-24A447E81C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4304B8-90B1-5D48-7AAE-CDBFA9C3C5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B3DEAA-D38E-4646-BDC7-CB021FCA16CB}" type="datetimeFigureOut">
              <a:rPr lang="fi-FI" smtClean="0"/>
              <a:t>12.5.2025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A1F301-05C0-F32D-3405-79DC837DD8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D0B00C-A1D0-C876-A840-6CC0629932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508C73-857A-46A2-A804-70F58F33EFF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33955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iruutu 1">
            <a:extLst>
              <a:ext uri="{FF2B5EF4-FFF2-40B4-BE49-F238E27FC236}">
                <a16:creationId xmlns:a16="http://schemas.microsoft.com/office/drawing/2014/main" id="{5FF2BF17-18E2-4563-97B7-398D788B79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2562" y="612773"/>
            <a:ext cx="2103438" cy="826799"/>
          </a:xfrm>
          <a:prstGeom prst="rect">
            <a:avLst/>
          </a:prstGeom>
          <a:solidFill>
            <a:srgbClr val="F2E9E4"/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04 993 Finnish women with one or more redeemed prescription for HC in 2017*</a:t>
            </a:r>
            <a:endParaRPr kumimoji="0" lang="en-US" altLang="fi-FI" sz="130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kstiruutu 2">
            <a:extLst>
              <a:ext uri="{FF2B5EF4-FFF2-40B4-BE49-F238E27FC236}">
                <a16:creationId xmlns:a16="http://schemas.microsoft.com/office/drawing/2014/main" id="{382D9D29-8D82-4D3F-B63B-42006753D2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8637" y="837479"/>
            <a:ext cx="2103437" cy="595890"/>
          </a:xfrm>
          <a:prstGeom prst="rect">
            <a:avLst/>
          </a:prstGeom>
          <a:solidFill>
            <a:srgbClr val="F2E9E4"/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group of 304 993 non-HC users**</a:t>
            </a:r>
            <a:endParaRPr kumimoji="0" lang="en-US" altLang="fi-FI" sz="130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kstiruutu 6">
            <a:extLst>
              <a:ext uri="{FF2B5EF4-FFF2-40B4-BE49-F238E27FC236}">
                <a16:creationId xmlns:a16="http://schemas.microsoft.com/office/drawing/2014/main" id="{CF6BDB0C-F950-425A-AA97-E7EBA7DD1A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86438" y="2210956"/>
            <a:ext cx="2003425" cy="921759"/>
          </a:xfrm>
          <a:prstGeom prst="rect">
            <a:avLst/>
          </a:prstGeom>
          <a:solidFill>
            <a:srgbClr val="C9ADA7">
              <a:alpha val="74902"/>
            </a:srgbClr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omen under 15 years and over 49 years old were excluded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 = 21 096)</a:t>
            </a:r>
            <a:endParaRPr kumimoji="0" lang="en-US" altLang="fi-FI" sz="130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kstiruutu 8">
            <a:extLst>
              <a:ext uri="{FF2B5EF4-FFF2-40B4-BE49-F238E27FC236}">
                <a16:creationId xmlns:a16="http://schemas.microsoft.com/office/drawing/2014/main" id="{8DA1964E-BDDB-432B-911E-312222B9EB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3836" y="3464862"/>
            <a:ext cx="1714137" cy="550935"/>
          </a:xfrm>
          <a:prstGeom prst="rect">
            <a:avLst/>
          </a:prstGeom>
          <a:solidFill>
            <a:srgbClr val="F2E9E4"/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together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88 712 women</a:t>
            </a:r>
            <a:endParaRPr kumimoji="0" lang="en-US" altLang="fi-FI" sz="130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kstiruutu 10">
            <a:extLst>
              <a:ext uri="{FF2B5EF4-FFF2-40B4-BE49-F238E27FC236}">
                <a16:creationId xmlns:a16="http://schemas.microsoft.com/office/drawing/2014/main" id="{DB04A495-0570-44E9-B8E5-E64E199315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8872" y="4380529"/>
            <a:ext cx="2524064" cy="1063625"/>
          </a:xfrm>
          <a:prstGeom prst="rect">
            <a:avLst/>
          </a:prstGeom>
          <a:solidFill>
            <a:srgbClr val="F2E9E4"/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omen having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ivery***</a:t>
            </a: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anuary 1</a:t>
            </a:r>
            <a:r>
              <a:rPr lang="en-US" altLang="fi-FI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019</a:t>
            </a: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</a:t>
            </a: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ember 31</a:t>
            </a:r>
            <a:r>
              <a:rPr lang="en-US" altLang="fi-FI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19  (n=</a:t>
            </a: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6 650</a:t>
            </a: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kumimoji="0" lang="en-US" altLang="fi-FI" sz="130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iruutu 13">
            <a:extLst>
              <a:ext uri="{FF2B5EF4-FFF2-40B4-BE49-F238E27FC236}">
                <a16:creationId xmlns:a16="http://schemas.microsoft.com/office/drawing/2014/main" id="{B5AF0DBE-E7CB-4618-8055-B513AEEC5B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31949" y="2133313"/>
            <a:ext cx="2330337" cy="1083613"/>
          </a:xfrm>
          <a:prstGeom prst="rect">
            <a:avLst/>
          </a:prstGeom>
          <a:solidFill>
            <a:srgbClr val="C9ADA7">
              <a:alpha val="74902"/>
            </a:srgbClr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omen with a </a:t>
            </a:r>
            <a:r>
              <a:rPr lang="en-US" altLang="fi-FI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scription</a:t>
            </a: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emergency contraception and their matched controls were excluded   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i-FI" sz="130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 = 178)</a:t>
            </a:r>
            <a:endParaRPr kumimoji="0" lang="en-US" altLang="fi-FI" sz="130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158E8DB3-53E5-40AD-A75E-2A478566B6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3250" y="2762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i-FI"/>
          </a:p>
        </p:txBody>
      </p:sp>
      <p:cxnSp>
        <p:nvCxnSpPr>
          <p:cNvPr id="14" name="Suora yhdysviiva 13">
            <a:extLst>
              <a:ext uri="{FF2B5EF4-FFF2-40B4-BE49-F238E27FC236}">
                <a16:creationId xmlns:a16="http://schemas.microsoft.com/office/drawing/2014/main" id="{9BAE5EA6-F991-4A3E-99A2-4D38A97EC43C}"/>
              </a:ext>
            </a:extLst>
          </p:cNvPr>
          <p:cNvCxnSpPr>
            <a:cxnSpLocks/>
          </p:cNvCxnSpPr>
          <p:nvPr/>
        </p:nvCxnSpPr>
        <p:spPr>
          <a:xfrm>
            <a:off x="6160905" y="2013527"/>
            <a:ext cx="0" cy="1451335"/>
          </a:xfrm>
          <a:prstGeom prst="line">
            <a:avLst/>
          </a:prstGeom>
          <a:ln w="28575">
            <a:solidFill>
              <a:srgbClr val="4A4E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uora yhdysviiva 21">
            <a:extLst>
              <a:ext uri="{FF2B5EF4-FFF2-40B4-BE49-F238E27FC236}">
                <a16:creationId xmlns:a16="http://schemas.microsoft.com/office/drawing/2014/main" id="{7EDE74BB-2CF9-425A-ABB4-062098DC7FED}"/>
              </a:ext>
            </a:extLst>
          </p:cNvPr>
          <p:cNvCxnSpPr>
            <a:cxnSpLocks/>
            <a:stCxn id="6" idx="3"/>
            <a:endCxn id="9" idx="1"/>
          </p:cNvCxnSpPr>
          <p:nvPr/>
        </p:nvCxnSpPr>
        <p:spPr>
          <a:xfrm>
            <a:off x="5489863" y="2671836"/>
            <a:ext cx="1342086" cy="3284"/>
          </a:xfrm>
          <a:prstGeom prst="line">
            <a:avLst/>
          </a:prstGeom>
          <a:ln w="28575">
            <a:solidFill>
              <a:srgbClr val="4A4E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uora yhdysviiva 23">
            <a:extLst>
              <a:ext uri="{FF2B5EF4-FFF2-40B4-BE49-F238E27FC236}">
                <a16:creationId xmlns:a16="http://schemas.microsoft.com/office/drawing/2014/main" id="{BC66AF04-79CE-4F7D-9C98-BA06B5BC61A6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 flipH="1">
            <a:off x="6160904" y="4015797"/>
            <a:ext cx="1" cy="364732"/>
          </a:xfrm>
          <a:prstGeom prst="line">
            <a:avLst/>
          </a:prstGeom>
          <a:ln w="28575">
            <a:solidFill>
              <a:srgbClr val="4A4E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Yhdistin: Kulma 30">
            <a:extLst>
              <a:ext uri="{FF2B5EF4-FFF2-40B4-BE49-F238E27FC236}">
                <a16:creationId xmlns:a16="http://schemas.microsoft.com/office/drawing/2014/main" id="{E8E45914-9259-D9B0-76F0-373A291A9FD6}"/>
              </a:ext>
            </a:extLst>
          </p:cNvPr>
          <p:cNvCxnSpPr>
            <a:cxnSpLocks/>
          </p:cNvCxnSpPr>
          <p:nvPr/>
        </p:nvCxnSpPr>
        <p:spPr>
          <a:xfrm rot="16200000" flipH="1">
            <a:off x="5312098" y="1171757"/>
            <a:ext cx="580990" cy="1116624"/>
          </a:xfrm>
          <a:prstGeom prst="bentConnector2">
            <a:avLst/>
          </a:prstGeom>
          <a:ln w="28575">
            <a:solidFill>
              <a:srgbClr val="4A4E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Yhdistin: Kulma 35">
            <a:extLst>
              <a:ext uri="{FF2B5EF4-FFF2-40B4-BE49-F238E27FC236}">
                <a16:creationId xmlns:a16="http://schemas.microsoft.com/office/drawing/2014/main" id="{8F26155B-F1CB-6C6D-D2BF-426B12325B27}"/>
              </a:ext>
            </a:extLst>
          </p:cNvPr>
          <p:cNvCxnSpPr>
            <a:cxnSpLocks/>
          </p:cNvCxnSpPr>
          <p:nvPr/>
        </p:nvCxnSpPr>
        <p:spPr>
          <a:xfrm rot="5400000">
            <a:off x="6512034" y="1082242"/>
            <a:ext cx="587194" cy="1289451"/>
          </a:xfrm>
          <a:prstGeom prst="bentConnector2">
            <a:avLst/>
          </a:prstGeom>
          <a:ln w="28575">
            <a:solidFill>
              <a:srgbClr val="4A4E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8E067AA-88F1-2BF5-ACFB-7576D3633A10}"/>
              </a:ext>
            </a:extLst>
          </p:cNvPr>
          <p:cNvSpPr txBox="1"/>
          <p:nvPr/>
        </p:nvSpPr>
        <p:spPr>
          <a:xfrm>
            <a:off x="213863" y="5544132"/>
            <a:ext cx="9660835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A. Flowchart of the study population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 = hormonal contraception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Information gathered from the Prescription Centre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Information gathered from the Social Insurance Institution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 Information gathered from the Finnish Medical Birth Register</a:t>
            </a:r>
          </a:p>
        </p:txBody>
      </p:sp>
    </p:spTree>
    <p:extLst>
      <p:ext uri="{BB962C8B-B14F-4D97-AF65-F5344CB8AC3E}">
        <p14:creationId xmlns:p14="http://schemas.microsoft.com/office/powerpoint/2010/main" val="1855785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15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äntti, Camilla E C</dc:creator>
  <cp:lastModifiedBy>Jäntti, Camilla E C</cp:lastModifiedBy>
  <cp:revision>3</cp:revision>
  <dcterms:created xsi:type="dcterms:W3CDTF">2025-05-12T09:00:25Z</dcterms:created>
  <dcterms:modified xsi:type="dcterms:W3CDTF">2025-05-12T09:18:33Z</dcterms:modified>
</cp:coreProperties>
</file>